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138" y="3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4393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040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3786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4835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75596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8804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9539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85237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14420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1966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1650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29686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90750" y="6210299"/>
            <a:ext cx="113411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/>
              <a:t>Figure 3:</a:t>
            </a:r>
            <a:r>
              <a:rPr lang="en-AU" sz="1000" dirty="0"/>
              <a:t> </a:t>
            </a:r>
            <a:r>
              <a:rPr lang="en-AU" sz="1000" b="1" dirty="0"/>
              <a:t>A.</a:t>
            </a:r>
            <a:r>
              <a:rPr lang="en-AU" sz="1000" dirty="0"/>
              <a:t> Comparison of amino acid sequence identities of (1-7) contigs from five shrimp species that matched with tropomyosin (TM) allergen, (8-9) known shrimp TM allergen, and (10-12) house dust mite and cockroach TM allergen. The sequence identities were calculated using multiple sequence alignment in </a:t>
            </a:r>
            <a:r>
              <a:rPr lang="en-AU" sz="1000" dirty="0" err="1"/>
              <a:t>Clustal</a:t>
            </a:r>
            <a:r>
              <a:rPr lang="en-AU" sz="1000" dirty="0"/>
              <a:t> Omega (EMBL-EBI). </a:t>
            </a:r>
            <a:r>
              <a:rPr lang="en-AU" sz="1000" b="1" dirty="0"/>
              <a:t>B.</a:t>
            </a:r>
            <a:r>
              <a:rPr lang="en-AU" sz="1000" dirty="0"/>
              <a:t> Molecular phylogenetic tree based on published amino acid sequences of Tropomyosin (TM) from edible crustacean and mollusc species; and allergy causing mite and insect species. The branches consist of </a:t>
            </a:r>
            <a:r>
              <a:rPr lang="en-AU" sz="1000" dirty="0" err="1"/>
              <a:t>UniProt</a:t>
            </a:r>
            <a:r>
              <a:rPr lang="en-AU" sz="1000" dirty="0"/>
              <a:t> ID/</a:t>
            </a:r>
            <a:r>
              <a:rPr lang="en-AU" sz="1000" dirty="0" err="1"/>
              <a:t>Genbank</a:t>
            </a:r>
            <a:r>
              <a:rPr lang="en-AU" sz="1000" dirty="0"/>
              <a:t> Accession ID, species name, and followed by common name in brackets. The numbers next to the branches indicate the bootstrap test percentage of 10,000 replicate trees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06538" y="163407"/>
            <a:ext cx="5132663" cy="59138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1493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13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James Cook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ymaviswanathan Karnaneedi</dc:creator>
  <cp:lastModifiedBy>Shaymaviswanathan Karnaneedi</cp:lastModifiedBy>
  <cp:revision>6</cp:revision>
  <dcterms:created xsi:type="dcterms:W3CDTF">2020-11-09T03:01:03Z</dcterms:created>
  <dcterms:modified xsi:type="dcterms:W3CDTF">2020-11-09T03:30:12Z</dcterms:modified>
</cp:coreProperties>
</file>